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2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77" d="100"/>
          <a:sy n="77" d="100"/>
        </p:scale>
        <p:origin x="-1560" y="-1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260918-29F5-2247-9FE9-E70C5C7AC4DE}" type="datetimeFigureOut">
              <a:rPr lang="en-US" smtClean="0"/>
              <a:t>5/3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C6B21-0925-F040-8363-486999D651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57137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260918-29F5-2247-9FE9-E70C5C7AC4DE}" type="datetimeFigureOut">
              <a:rPr lang="en-US" smtClean="0"/>
              <a:t>5/3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C6B21-0925-F040-8363-486999D651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39863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260918-29F5-2247-9FE9-E70C5C7AC4DE}" type="datetimeFigureOut">
              <a:rPr lang="en-US" smtClean="0"/>
              <a:t>5/3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C6B21-0925-F040-8363-486999D651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44942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260918-29F5-2247-9FE9-E70C5C7AC4DE}" type="datetimeFigureOut">
              <a:rPr lang="en-US" smtClean="0"/>
              <a:t>5/3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C6B21-0925-F040-8363-486999D651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33762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260918-29F5-2247-9FE9-E70C5C7AC4DE}" type="datetimeFigureOut">
              <a:rPr lang="en-US" smtClean="0"/>
              <a:t>5/3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C6B21-0925-F040-8363-486999D651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00479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260918-29F5-2247-9FE9-E70C5C7AC4DE}" type="datetimeFigureOut">
              <a:rPr lang="en-US" smtClean="0"/>
              <a:t>5/3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C6B21-0925-F040-8363-486999D651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92838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260918-29F5-2247-9FE9-E70C5C7AC4DE}" type="datetimeFigureOut">
              <a:rPr lang="en-US" smtClean="0"/>
              <a:t>5/31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C6B21-0925-F040-8363-486999D651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27234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260918-29F5-2247-9FE9-E70C5C7AC4DE}" type="datetimeFigureOut">
              <a:rPr lang="en-US" smtClean="0"/>
              <a:t>5/31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C6B21-0925-F040-8363-486999D651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70323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260918-29F5-2247-9FE9-E70C5C7AC4DE}" type="datetimeFigureOut">
              <a:rPr lang="en-US" smtClean="0"/>
              <a:t>5/31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C6B21-0925-F040-8363-486999D651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26227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260918-29F5-2247-9FE9-E70C5C7AC4DE}" type="datetimeFigureOut">
              <a:rPr lang="en-US" smtClean="0"/>
              <a:t>5/3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C6B21-0925-F040-8363-486999D651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67874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260918-29F5-2247-9FE9-E70C5C7AC4DE}" type="datetimeFigureOut">
              <a:rPr lang="en-US" smtClean="0"/>
              <a:t>5/3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C6B21-0925-F040-8363-486999D651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04800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260918-29F5-2247-9FE9-E70C5C7AC4DE}" type="datetimeFigureOut">
              <a:rPr lang="en-US" smtClean="0"/>
              <a:t>5/3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4C6B21-0925-F040-8363-486999D651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7557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ella 4"/>
          <p:cNvGraphicFramePr>
            <a:graphicFrameLocks noGrp="1"/>
          </p:cNvGraphicFramePr>
          <p:nvPr/>
        </p:nvGraphicFramePr>
        <p:xfrm>
          <a:off x="1364731" y="448132"/>
          <a:ext cx="4096793" cy="8444250"/>
        </p:xfrm>
        <a:graphic>
          <a:graphicData uri="http://schemas.openxmlformats.org/drawingml/2006/table">
            <a:tbl>
              <a:tblPr/>
              <a:tblGrid>
                <a:gridCol w="1480972"/>
                <a:gridCol w="1000676"/>
                <a:gridCol w="751892"/>
                <a:gridCol w="863253"/>
              </a:tblGrid>
              <a:tr h="187650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val 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FDR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log2 fold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7650">
                <a:tc>
                  <a:txBody>
                    <a:bodyPr/>
                    <a:lstStyle/>
                    <a:p>
                      <a:pPr algn="l" fontAlgn="b"/>
                      <a:endParaRPr lang="it-IT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87650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150-3p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2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91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650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3679-5p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8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47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650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361-5p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6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74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650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195-5p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5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86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650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30a-5p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5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44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650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19b-3p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6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73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650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1273g-3p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5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1.07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650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1268b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6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31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650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152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5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20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650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4306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5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.15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650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151a-5p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5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66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650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26a-5p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5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58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650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3663-3p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7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81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650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142-3p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2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8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28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650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18b-5p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2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9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51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650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335-5p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2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9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43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650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10a-5p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2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9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52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650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151a-3p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2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20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58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650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5194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3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20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14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650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331-3p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3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21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92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650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3907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3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21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48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650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34b-5p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3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21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94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650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892b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3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21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08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650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939-5p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3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21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28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650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6085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3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20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54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650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2861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3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20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79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650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211-3p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3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20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27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650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574-3p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3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9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63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650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28-5p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4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20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11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650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30e-5p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4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9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79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650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18a-5p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4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9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68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650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129-2-3p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4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20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50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650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185-5p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4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21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64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650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4713-3p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4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20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0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650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3198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5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20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5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650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140-5p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5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21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34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650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221-5p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5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21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78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650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107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5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20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93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650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9-3p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5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20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15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650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30b-5p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5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21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01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650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27b-3p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5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20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94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650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4499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5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20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53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650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sa-miR-625-5p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5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20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82</a:t>
                      </a:r>
                    </a:p>
                  </a:txBody>
                  <a:tcPr marL="4770" marR="4770" marT="47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4" name="CasellaDiTesto 9"/>
          <p:cNvSpPr txBox="1"/>
          <p:nvPr/>
        </p:nvSpPr>
        <p:spPr>
          <a:xfrm>
            <a:off x="-23905" y="-64964"/>
            <a:ext cx="1854200" cy="283941"/>
          </a:xfrm>
          <a:prstGeom prst="rect">
            <a:avLst/>
          </a:prstGeom>
          <a:noFill/>
        </p:spPr>
        <p:txBody>
          <a:bodyPr wrap="square" lIns="91428" tIns="45714" rIns="91428" bIns="45714" rtlCol="0">
            <a:spAutoFit/>
          </a:bodyPr>
          <a:lstStyle/>
          <a:p>
            <a:r>
              <a:rPr lang="en-US" sz="1200" b="1" dirty="0" smtClean="0"/>
              <a:t>Figure S6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20143481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84</Words>
  <Application>Microsoft Office PowerPoint</Application>
  <PresentationFormat>On-screen Show (4:3)</PresentationFormat>
  <Paragraphs>17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if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 donzelli</dc:creator>
  <cp:lastModifiedBy>Balindan, Danica Joy</cp:lastModifiedBy>
  <cp:revision>11</cp:revision>
  <dcterms:created xsi:type="dcterms:W3CDTF">2017-05-19T15:04:48Z</dcterms:created>
  <dcterms:modified xsi:type="dcterms:W3CDTF">2017-05-31T01:11:07Z</dcterms:modified>
</cp:coreProperties>
</file>